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8" r:id="rId3"/>
    <p:sldId id="261" r:id="rId4"/>
    <p:sldId id="267" r:id="rId5"/>
    <p:sldId id="264" r:id="rId6"/>
    <p:sldId id="257" r:id="rId7"/>
    <p:sldId id="263" r:id="rId8"/>
    <p:sldId id="260" r:id="rId9"/>
    <p:sldId id="266" r:id="rId10"/>
    <p:sldId id="262" r:id="rId11"/>
    <p:sldId id="265" r:id="rId12"/>
    <p:sldId id="259" r:id="rId13"/>
    <p:sldId id="258" r:id="rId1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66" d="100"/>
          <a:sy n="66" d="100"/>
        </p:scale>
        <p:origin x="79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75A9B-08A5-4A25-A74D-46B80EC5D7FC}" type="datetimeFigureOut">
              <a:rPr lang="zh-CN" altLang="en-US" smtClean="0"/>
              <a:t>2018/10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A4052-4927-4A16-BB31-C7BA6FB60D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46021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75A9B-08A5-4A25-A74D-46B80EC5D7FC}" type="datetimeFigureOut">
              <a:rPr lang="zh-CN" altLang="en-US" smtClean="0"/>
              <a:t>2018/10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A4052-4927-4A16-BB31-C7BA6FB60D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953840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75A9B-08A5-4A25-A74D-46B80EC5D7FC}" type="datetimeFigureOut">
              <a:rPr lang="zh-CN" altLang="en-US" smtClean="0"/>
              <a:t>2018/10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A4052-4927-4A16-BB31-C7BA6FB60D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3299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75A9B-08A5-4A25-A74D-46B80EC5D7FC}" type="datetimeFigureOut">
              <a:rPr lang="zh-CN" altLang="en-US" smtClean="0"/>
              <a:t>2018/10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A4052-4927-4A16-BB31-C7BA6FB60D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82850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75A9B-08A5-4A25-A74D-46B80EC5D7FC}" type="datetimeFigureOut">
              <a:rPr lang="zh-CN" altLang="en-US" smtClean="0"/>
              <a:t>2018/10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A4052-4927-4A16-BB31-C7BA6FB60D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95345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75A9B-08A5-4A25-A74D-46B80EC5D7FC}" type="datetimeFigureOut">
              <a:rPr lang="zh-CN" altLang="en-US" smtClean="0"/>
              <a:t>2018/10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A4052-4927-4A16-BB31-C7BA6FB60D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39902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75A9B-08A5-4A25-A74D-46B80EC5D7FC}" type="datetimeFigureOut">
              <a:rPr lang="zh-CN" altLang="en-US" smtClean="0"/>
              <a:t>2018/10/2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A4052-4927-4A16-BB31-C7BA6FB60D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63570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75A9B-08A5-4A25-A74D-46B80EC5D7FC}" type="datetimeFigureOut">
              <a:rPr lang="zh-CN" altLang="en-US" smtClean="0"/>
              <a:t>2018/10/2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A4052-4927-4A16-BB31-C7BA6FB60D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21034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75A9B-08A5-4A25-A74D-46B80EC5D7FC}" type="datetimeFigureOut">
              <a:rPr lang="zh-CN" altLang="en-US" smtClean="0"/>
              <a:t>2018/10/2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A4052-4927-4A16-BB31-C7BA6FB60D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833468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75A9B-08A5-4A25-A74D-46B80EC5D7FC}" type="datetimeFigureOut">
              <a:rPr lang="zh-CN" altLang="en-US" smtClean="0"/>
              <a:t>2018/10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A4052-4927-4A16-BB31-C7BA6FB60D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87262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75A9B-08A5-4A25-A74D-46B80EC5D7FC}" type="datetimeFigureOut">
              <a:rPr lang="zh-CN" altLang="en-US" smtClean="0"/>
              <a:t>2018/10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A4052-4927-4A16-BB31-C7BA6FB60D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16455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B75A9B-08A5-4A25-A74D-46B80EC5D7FC}" type="datetimeFigureOut">
              <a:rPr lang="zh-CN" altLang="en-US" smtClean="0"/>
              <a:t>2018/10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5A4052-4927-4A16-BB31-C7BA6FB60D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67828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eg"/><Relationship Id="rId2" Type="http://schemas.openxmlformats.org/officeDocument/2006/relationships/image" Target="../media/image19.jpe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image" Target="../media/image2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2.jpe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jpeg"/><Relationship Id="rId2" Type="http://schemas.openxmlformats.org/officeDocument/2006/relationships/image" Target="../media/image23.jpe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jpeg"/><Relationship Id="rId2" Type="http://schemas.openxmlformats.org/officeDocument/2006/relationships/image" Target="../media/image25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eg"/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表格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0494402"/>
              </p:ext>
            </p:extLst>
          </p:nvPr>
        </p:nvGraphicFramePr>
        <p:xfrm>
          <a:off x="716114" y="5746633"/>
          <a:ext cx="11133570" cy="6400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03197"/>
                <a:gridCol w="3154289"/>
                <a:gridCol w="1544320"/>
                <a:gridCol w="2138289"/>
                <a:gridCol w="1364566"/>
                <a:gridCol w="2128909"/>
              </a:tblGrid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Gene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Elongation Factor </a:t>
                      </a:r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-alpha</a:t>
                      </a:r>
                    </a:p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(Reference gene)</a:t>
                      </a:r>
                      <a:endParaRPr lang="zh-CN" altLang="en-US" sz="1800" b="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CR Efficiency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05.81%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elt Peak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84.573</a:t>
                      </a:r>
                      <a:endParaRPr lang="zh-CN" altLang="en-US" sz="1800" b="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pic>
        <p:nvPicPr>
          <p:cNvPr id="10" name="图片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9058" y="787791"/>
            <a:ext cx="6912000" cy="432000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345" y="647115"/>
            <a:ext cx="4944743" cy="50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856714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9058" y="782164"/>
            <a:ext cx="6912000" cy="43200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47115"/>
            <a:ext cx="4944742" cy="5040000"/>
          </a:xfrm>
          <a:prstGeom prst="rect">
            <a:avLst/>
          </a:prstGeom>
        </p:spPr>
      </p:pic>
      <p:graphicFrame>
        <p:nvGraphicFramePr>
          <p:cNvPr id="9" name="表格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51853251"/>
              </p:ext>
            </p:extLst>
          </p:nvPr>
        </p:nvGraphicFramePr>
        <p:xfrm>
          <a:off x="716114" y="5746633"/>
          <a:ext cx="11133570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03197"/>
                <a:gridCol w="3110746"/>
                <a:gridCol w="1587863"/>
                <a:gridCol w="2138289"/>
                <a:gridCol w="1364566"/>
                <a:gridCol w="2128909"/>
              </a:tblGrid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Gene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avir.7NG306800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CR Efficiency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06.44%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elt Peak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90.673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134189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47115"/>
            <a:ext cx="4944742" cy="5040000"/>
          </a:xfrm>
          <a:prstGeom prst="rect">
            <a:avLst/>
          </a:prstGeom>
        </p:spPr>
      </p:pic>
      <p:graphicFrame>
        <p:nvGraphicFramePr>
          <p:cNvPr id="9" name="表格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36364740"/>
              </p:ext>
            </p:extLst>
          </p:nvPr>
        </p:nvGraphicFramePr>
        <p:xfrm>
          <a:off x="716114" y="5746633"/>
          <a:ext cx="11133570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03197"/>
                <a:gridCol w="3110746"/>
                <a:gridCol w="1587863"/>
                <a:gridCol w="2138289"/>
                <a:gridCol w="1364566"/>
                <a:gridCol w="2128909"/>
              </a:tblGrid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Gene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avir.8KG390300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CR Efficiency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03.47%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elt Peak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83.829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pic>
        <p:nvPicPr>
          <p:cNvPr id="10" name="图片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9058" y="787791"/>
            <a:ext cx="6912000" cy="4320000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9058" y="787795"/>
            <a:ext cx="6912000" cy="43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2828986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9058" y="782164"/>
            <a:ext cx="6912000" cy="4320000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345" y="647115"/>
            <a:ext cx="4944742" cy="5040000"/>
          </a:xfrm>
          <a:prstGeom prst="rect">
            <a:avLst/>
          </a:prstGeom>
        </p:spPr>
      </p:pic>
      <p:graphicFrame>
        <p:nvGraphicFramePr>
          <p:cNvPr id="9" name="表格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53016531"/>
              </p:ext>
            </p:extLst>
          </p:nvPr>
        </p:nvGraphicFramePr>
        <p:xfrm>
          <a:off x="716114" y="5746633"/>
          <a:ext cx="11133570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03197"/>
                <a:gridCol w="3110746"/>
                <a:gridCol w="1587863"/>
                <a:gridCol w="2138289"/>
                <a:gridCol w="1364566"/>
                <a:gridCol w="2128909"/>
              </a:tblGrid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Gene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avir.8NG161900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CR Efficiency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07.95%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elt Peak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80.919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4368845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9058" y="787791"/>
            <a:ext cx="6912000" cy="4320000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345" y="647115"/>
            <a:ext cx="4944742" cy="5040000"/>
          </a:xfrm>
          <a:prstGeom prst="rect">
            <a:avLst/>
          </a:prstGeom>
        </p:spPr>
      </p:pic>
      <p:graphicFrame>
        <p:nvGraphicFramePr>
          <p:cNvPr id="9" name="表格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39854087"/>
              </p:ext>
            </p:extLst>
          </p:nvPr>
        </p:nvGraphicFramePr>
        <p:xfrm>
          <a:off x="716114" y="5746633"/>
          <a:ext cx="11133570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03197"/>
                <a:gridCol w="3110746"/>
                <a:gridCol w="1587863"/>
                <a:gridCol w="2138289"/>
                <a:gridCol w="1364566"/>
                <a:gridCol w="2128909"/>
              </a:tblGrid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Gene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avir.J517000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CR Efficiency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06.94%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elt Peak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83.725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569810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9058" y="787791"/>
            <a:ext cx="6912000" cy="432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345" y="647115"/>
            <a:ext cx="4944742" cy="5040000"/>
          </a:xfrm>
          <a:prstGeom prst="rect">
            <a:avLst/>
          </a:prstGeom>
        </p:spPr>
      </p:pic>
      <p:graphicFrame>
        <p:nvGraphicFramePr>
          <p:cNvPr id="9" name="表格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02777078"/>
              </p:ext>
            </p:extLst>
          </p:nvPr>
        </p:nvGraphicFramePr>
        <p:xfrm>
          <a:off x="716114" y="5746633"/>
          <a:ext cx="11133570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03197"/>
                <a:gridCol w="3110746"/>
                <a:gridCol w="1587863"/>
                <a:gridCol w="2138289"/>
                <a:gridCol w="1364566"/>
                <a:gridCol w="2128909"/>
              </a:tblGrid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Gene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avir.1KG404800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CR Efficiency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03.03%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elt Peak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88.337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628147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9058" y="787791"/>
            <a:ext cx="6912000" cy="43200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345" y="647115"/>
            <a:ext cx="4944742" cy="5040000"/>
          </a:xfrm>
          <a:prstGeom prst="rect">
            <a:avLst/>
          </a:prstGeom>
        </p:spPr>
      </p:pic>
      <p:graphicFrame>
        <p:nvGraphicFramePr>
          <p:cNvPr id="9" name="表格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13340023"/>
              </p:ext>
            </p:extLst>
          </p:nvPr>
        </p:nvGraphicFramePr>
        <p:xfrm>
          <a:off x="716114" y="5746633"/>
          <a:ext cx="11133570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03197"/>
                <a:gridCol w="3110746"/>
                <a:gridCol w="1587863"/>
                <a:gridCol w="2138289"/>
                <a:gridCol w="1364566"/>
                <a:gridCol w="2128909"/>
              </a:tblGrid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Gene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avir.1KG545400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CR Efficiency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06.62%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elt Peak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82.257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258559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9058" y="787791"/>
            <a:ext cx="6912000" cy="432000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345" y="647115"/>
            <a:ext cx="4944742" cy="5040000"/>
          </a:xfrm>
          <a:prstGeom prst="rect">
            <a:avLst/>
          </a:prstGeom>
        </p:spPr>
      </p:pic>
      <p:graphicFrame>
        <p:nvGraphicFramePr>
          <p:cNvPr id="9" name="表格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01540038"/>
              </p:ext>
            </p:extLst>
          </p:nvPr>
        </p:nvGraphicFramePr>
        <p:xfrm>
          <a:off x="716114" y="5746633"/>
          <a:ext cx="11133570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03197"/>
                <a:gridCol w="3110746"/>
                <a:gridCol w="1587863"/>
                <a:gridCol w="2138289"/>
                <a:gridCol w="1364566"/>
                <a:gridCol w="2128909"/>
              </a:tblGrid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Gene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avir.2KG439000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CR Efficiency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04.44%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elt Peak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84.598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61420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9058" y="782164"/>
            <a:ext cx="6912000" cy="43200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47115"/>
            <a:ext cx="4944742" cy="5040000"/>
          </a:xfrm>
          <a:prstGeom prst="rect">
            <a:avLst/>
          </a:prstGeom>
        </p:spPr>
      </p:pic>
      <p:graphicFrame>
        <p:nvGraphicFramePr>
          <p:cNvPr id="9" name="表格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74383494"/>
              </p:ext>
            </p:extLst>
          </p:nvPr>
        </p:nvGraphicFramePr>
        <p:xfrm>
          <a:off x="716114" y="5746633"/>
          <a:ext cx="11133570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03197"/>
                <a:gridCol w="3110746"/>
                <a:gridCol w="1587863"/>
                <a:gridCol w="2138289"/>
                <a:gridCol w="1364566"/>
                <a:gridCol w="2128909"/>
              </a:tblGrid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Gene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avir.2NG586800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CR Efficiency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04.44%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elt Peak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83.206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7032171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9058" y="787791"/>
            <a:ext cx="6912000" cy="4320000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345" y="647115"/>
            <a:ext cx="4944742" cy="5040000"/>
          </a:xfrm>
          <a:prstGeom prst="rect">
            <a:avLst/>
          </a:prstGeom>
        </p:spPr>
      </p:pic>
      <p:graphicFrame>
        <p:nvGraphicFramePr>
          <p:cNvPr id="9" name="表格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53334672"/>
              </p:ext>
            </p:extLst>
          </p:nvPr>
        </p:nvGraphicFramePr>
        <p:xfrm>
          <a:off x="716114" y="5746633"/>
          <a:ext cx="11133570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03197"/>
                <a:gridCol w="3110746"/>
                <a:gridCol w="1587863"/>
                <a:gridCol w="2138289"/>
                <a:gridCol w="1364566"/>
                <a:gridCol w="2128909"/>
              </a:tblGrid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Gene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avir.3KG025800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CR Efficiency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99.65%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elt Peak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86.373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7879228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9058" y="782164"/>
            <a:ext cx="6912000" cy="43200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47115"/>
            <a:ext cx="4944742" cy="5040000"/>
          </a:xfrm>
          <a:prstGeom prst="rect">
            <a:avLst/>
          </a:prstGeom>
        </p:spPr>
      </p:pic>
      <p:graphicFrame>
        <p:nvGraphicFramePr>
          <p:cNvPr id="9" name="表格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32958369"/>
              </p:ext>
            </p:extLst>
          </p:nvPr>
        </p:nvGraphicFramePr>
        <p:xfrm>
          <a:off x="716114" y="5746633"/>
          <a:ext cx="11133570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03197"/>
                <a:gridCol w="3110746"/>
                <a:gridCol w="1587863"/>
                <a:gridCol w="2138289"/>
                <a:gridCol w="1364566"/>
                <a:gridCol w="2128909"/>
              </a:tblGrid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Gene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avir.3NG053500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CR Efficiency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01.80%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elt Peak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86.614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8519503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345" y="647115"/>
            <a:ext cx="4944742" cy="5040000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9058" y="782164"/>
            <a:ext cx="6912000" cy="4320000"/>
          </a:xfrm>
          <a:prstGeom prst="rect">
            <a:avLst/>
          </a:prstGeom>
        </p:spPr>
      </p:pic>
      <p:graphicFrame>
        <p:nvGraphicFramePr>
          <p:cNvPr id="9" name="表格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70521438"/>
              </p:ext>
            </p:extLst>
          </p:nvPr>
        </p:nvGraphicFramePr>
        <p:xfrm>
          <a:off x="716114" y="5746633"/>
          <a:ext cx="11133570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03197"/>
                <a:gridCol w="3110746"/>
                <a:gridCol w="1587863"/>
                <a:gridCol w="2138289"/>
                <a:gridCol w="1364566"/>
                <a:gridCol w="2128909"/>
              </a:tblGrid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Gene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avir.5NG047700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CR Efficiency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81.98%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elt Peak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92.339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5645872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345" y="647115"/>
            <a:ext cx="4944742" cy="5040000"/>
          </a:xfrm>
          <a:prstGeom prst="rect">
            <a:avLst/>
          </a:prstGeom>
        </p:spPr>
      </p:pic>
      <p:graphicFrame>
        <p:nvGraphicFramePr>
          <p:cNvPr id="9" name="表格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38778186"/>
              </p:ext>
            </p:extLst>
          </p:nvPr>
        </p:nvGraphicFramePr>
        <p:xfrm>
          <a:off x="716114" y="5746633"/>
          <a:ext cx="11133570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03197"/>
                <a:gridCol w="3110746"/>
                <a:gridCol w="1587863"/>
                <a:gridCol w="2138289"/>
                <a:gridCol w="1364566"/>
                <a:gridCol w="2128909"/>
              </a:tblGrid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Gene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avir.7NG099700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CR Efficiency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08.28%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1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elt Peak:</a:t>
                      </a:r>
                      <a:endParaRPr lang="zh-CN" altLang="en-US" sz="18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800" b="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79.756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pic>
        <p:nvPicPr>
          <p:cNvPr id="10" name="图片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9058" y="787791"/>
            <a:ext cx="6912000" cy="4320000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9058" y="782164"/>
            <a:ext cx="6912000" cy="43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981178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</TotalTime>
  <Words>162</Words>
  <Application>Microsoft Office PowerPoint</Application>
  <PresentationFormat>宽屏</PresentationFormat>
  <Paragraphs>79</Paragraphs>
  <Slides>1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3</vt:i4>
      </vt:variant>
    </vt:vector>
  </HeadingPairs>
  <TitlesOfParts>
    <vt:vector size="18" baseType="lpstr"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勇锋</dc:creator>
  <cp:lastModifiedBy>王 勇锋</cp:lastModifiedBy>
  <cp:revision>12</cp:revision>
  <dcterms:created xsi:type="dcterms:W3CDTF">2018-10-28T09:18:07Z</dcterms:created>
  <dcterms:modified xsi:type="dcterms:W3CDTF">2018-10-28T11:48:56Z</dcterms:modified>
</cp:coreProperties>
</file>